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947275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61720-8D5A-41A6-B132-86E33E05AC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D73235-1BE7-4968-9865-9370722124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53DB8-6A73-419D-8C13-FA20D98866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10528-3AC7-4AE2-8FAE-D08E45DB10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5E270-F106-4734-B8B4-AC497D2F26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47519-C98C-4299-8713-9B7AB72A88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364986-C754-4964-806F-D6187280CF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C63148-18CC-4029-8312-1F294188B4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8EE324-F187-4396-8C72-BEEF82B935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C7D459-0CF4-4108-A8BC-5C84540EBD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575CB-86D7-47AD-A74C-9A830CCF57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113A9-99C0-4983-9A42-539811B699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D65921-A493-4F61-8DC0-6C8BFB1024DA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8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2"/>
          <p:cNvSpPr/>
          <p:nvPr/>
        </p:nvSpPr>
        <p:spPr>
          <a:xfrm>
            <a:off x="697680" y="482436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73"/>
          <p:cNvSpPr/>
          <p:nvPr/>
        </p:nvSpPr>
        <p:spPr>
          <a:xfrm>
            <a:off x="618480" y="24732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3" name="组合 2"/>
          <p:cNvGrpSpPr/>
          <p:nvPr/>
        </p:nvGrpSpPr>
        <p:grpSpPr>
          <a:xfrm>
            <a:off x="1101600" y="2359440"/>
            <a:ext cx="4208400" cy="2208960"/>
            <a:chOff x="1101600" y="2359440"/>
            <a:chExt cx="4208400" cy="2208960"/>
          </a:xfrm>
        </p:grpSpPr>
        <p:grpSp>
          <p:nvGrpSpPr>
            <p:cNvPr id="44" name="组合 19"/>
            <p:cNvGrpSpPr/>
            <p:nvPr/>
          </p:nvGrpSpPr>
          <p:grpSpPr>
            <a:xfrm>
              <a:off x="1401840" y="2359440"/>
              <a:ext cx="3908160" cy="2208960"/>
              <a:chOff x="1401840" y="2359440"/>
              <a:chExt cx="3908160" cy="2208960"/>
            </a:xfrm>
          </p:grpSpPr>
          <p:pic>
            <p:nvPicPr>
              <p:cNvPr id="45" name="Picture 4" descr="2014-04-17-DLD-1-p27 shRNA_"/>
              <p:cNvPicPr/>
              <p:nvPr/>
            </p:nvPicPr>
            <p:blipFill>
              <a:blip r:embed="rId1"/>
              <a:srcRect l="25723" t="28726" r="56132" b="66823"/>
              <a:stretch/>
            </p:blipFill>
            <p:spPr>
              <a:xfrm>
                <a:off x="1403280" y="3384360"/>
                <a:ext cx="1576440" cy="439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5" descr="2014-04-17-DLD-1-p27 shRNA_"/>
              <p:cNvPicPr/>
              <p:nvPr/>
            </p:nvPicPr>
            <p:blipFill>
              <a:blip r:embed="rId2"/>
              <a:srcRect l="25723" t="18439" r="56132" b="76962"/>
              <a:stretch/>
            </p:blipFill>
            <p:spPr>
              <a:xfrm>
                <a:off x="1401840" y="3859560"/>
                <a:ext cx="1577160" cy="415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Picture 22" descr="2014-04-17-DLD-1-p27 shRNA_Right GAPDH"/>
              <p:cNvPicPr/>
              <p:nvPr/>
            </p:nvPicPr>
            <p:blipFill>
              <a:blip r:embed="rId3"/>
              <a:srcRect l="13491" t="71090" r="52640" b="8017"/>
              <a:stretch/>
            </p:blipFill>
            <p:spPr>
              <a:xfrm>
                <a:off x="3024720" y="3859560"/>
                <a:ext cx="1577160" cy="424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23" descr="2014-04-17-DLD-1-p27 shRNA_Right p27"/>
              <p:cNvPicPr/>
              <p:nvPr/>
            </p:nvPicPr>
            <p:blipFill>
              <a:blip r:embed="rId4"/>
              <a:srcRect l="13105" t="22234" r="52925" b="46862"/>
              <a:stretch/>
            </p:blipFill>
            <p:spPr>
              <a:xfrm>
                <a:off x="3022200" y="3382920"/>
                <a:ext cx="1577160" cy="440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9" name="Text Box 9"/>
              <p:cNvSpPr/>
              <p:nvPr/>
            </p:nvSpPr>
            <p:spPr>
              <a:xfrm rot="18276600">
                <a:off x="3949560" y="2783520"/>
                <a:ext cx="1102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27 shRNA 2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Text Box 9"/>
              <p:cNvSpPr/>
              <p:nvPr/>
            </p:nvSpPr>
            <p:spPr>
              <a:xfrm rot="18276600">
                <a:off x="3517560" y="2792880"/>
                <a:ext cx="1057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27 shRNA 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Text Box 7"/>
              <p:cNvSpPr/>
              <p:nvPr/>
            </p:nvSpPr>
            <p:spPr>
              <a:xfrm rot="18276600">
                <a:off x="3090240" y="2961720"/>
                <a:ext cx="71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Text Box 9"/>
              <p:cNvSpPr/>
              <p:nvPr/>
            </p:nvSpPr>
            <p:spPr>
              <a:xfrm rot="18276600">
                <a:off x="2365560" y="2761920"/>
                <a:ext cx="1124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27 shRNA 2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Text Box 9"/>
              <p:cNvSpPr/>
              <p:nvPr/>
            </p:nvSpPr>
            <p:spPr>
              <a:xfrm rot="18276600">
                <a:off x="1885680" y="2772000"/>
                <a:ext cx="1099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27 shRNA 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Text Box 7"/>
              <p:cNvSpPr/>
              <p:nvPr/>
            </p:nvSpPr>
            <p:spPr>
              <a:xfrm rot="18276600">
                <a:off x="1461600" y="2951640"/>
                <a:ext cx="71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TextBox 14"/>
              <p:cNvSpPr/>
              <p:nvPr/>
            </p:nvSpPr>
            <p:spPr>
              <a:xfrm>
                <a:off x="3430440" y="4291920"/>
                <a:ext cx="59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2780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TextBox 16"/>
              <p:cNvSpPr/>
              <p:nvPr/>
            </p:nvSpPr>
            <p:spPr>
              <a:xfrm>
                <a:off x="1921320" y="4291920"/>
                <a:ext cx="628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LD-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Text Box 17"/>
              <p:cNvSpPr/>
              <p:nvPr/>
            </p:nvSpPr>
            <p:spPr>
              <a:xfrm>
                <a:off x="4593960" y="3442680"/>
                <a:ext cx="4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27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Text Box 18"/>
              <p:cNvSpPr/>
              <p:nvPr/>
            </p:nvSpPr>
            <p:spPr>
              <a:xfrm>
                <a:off x="4579200" y="3889800"/>
                <a:ext cx="730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GAPDH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59" name="TextBox 120"/>
            <p:cNvSpPr/>
            <p:nvPr/>
          </p:nvSpPr>
          <p:spPr>
            <a:xfrm>
              <a:off x="1134720" y="3475080"/>
              <a:ext cx="380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7 - ­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TextBox 121"/>
            <p:cNvSpPr/>
            <p:nvPr/>
          </p:nvSpPr>
          <p:spPr>
            <a:xfrm>
              <a:off x="1134000" y="3944880"/>
              <a:ext cx="356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7 -­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TextBox 122"/>
            <p:cNvSpPr/>
            <p:nvPr/>
          </p:nvSpPr>
          <p:spPr>
            <a:xfrm>
              <a:off x="1101600" y="3176640"/>
              <a:ext cx="34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62" name="组合 1"/>
          <p:cNvGrpSpPr/>
          <p:nvPr/>
        </p:nvGrpSpPr>
        <p:grpSpPr>
          <a:xfrm>
            <a:off x="923760" y="4411440"/>
            <a:ext cx="5210280" cy="2715840"/>
            <a:chOff x="923760" y="4411440"/>
            <a:chExt cx="5210280" cy="2715840"/>
          </a:xfrm>
        </p:grpSpPr>
        <p:grpSp>
          <p:nvGrpSpPr>
            <p:cNvPr id="63" name="组合 42"/>
            <p:cNvGrpSpPr/>
            <p:nvPr/>
          </p:nvGrpSpPr>
          <p:grpSpPr>
            <a:xfrm>
              <a:off x="1196280" y="4411440"/>
              <a:ext cx="4937760" cy="2715840"/>
              <a:chOff x="1196280" y="4411440"/>
              <a:chExt cx="4937760" cy="2715840"/>
            </a:xfrm>
          </p:grpSpPr>
          <p:sp>
            <p:nvSpPr>
              <p:cNvPr id="64" name="Text Box 9"/>
              <p:cNvSpPr/>
              <p:nvPr/>
            </p:nvSpPr>
            <p:spPr>
              <a:xfrm rot="18276600">
                <a:off x="4435560" y="4993560"/>
                <a:ext cx="131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CBP1-p27 sh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Text Box 9"/>
              <p:cNvSpPr/>
              <p:nvPr/>
            </p:nvSpPr>
            <p:spPr>
              <a:xfrm rot="18276600">
                <a:off x="2692800" y="4949640"/>
                <a:ext cx="1453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CBP1-p27 sh2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Text Box 9"/>
              <p:cNvSpPr/>
              <p:nvPr/>
            </p:nvSpPr>
            <p:spPr>
              <a:xfrm rot="18276600">
                <a:off x="2162880" y="4968720"/>
                <a:ext cx="1405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CBP1-p27 sh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67" name="组合 41"/>
              <p:cNvGrpSpPr/>
              <p:nvPr/>
            </p:nvGrpSpPr>
            <p:grpSpPr>
              <a:xfrm>
                <a:off x="1196280" y="4743720"/>
                <a:ext cx="4937760" cy="2383560"/>
                <a:chOff x="1196280" y="4743720"/>
                <a:chExt cx="4937760" cy="2383560"/>
              </a:xfrm>
            </p:grpSpPr>
            <p:pic>
              <p:nvPicPr>
                <p:cNvPr id="68" name="Picture 4" descr="2014-10-13-A2780 PCBP1 Mutation _WB for p27 sh1-GAPDH "/>
                <p:cNvPicPr/>
                <p:nvPr/>
              </p:nvPicPr>
              <p:blipFill>
                <a:blip r:embed="rId5">
                  <a:lum contrast="12000"/>
                </a:blip>
                <a:srcRect l="13322" t="10980" r="58943" b="67059"/>
                <a:stretch/>
              </p:blipFill>
              <p:spPr>
                <a:xfrm>
                  <a:off x="3432960" y="6438240"/>
                  <a:ext cx="1726560" cy="4096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9" name="Picture 5" descr="2014-10-13-A2780 PCBP1 Mutation _WB for p27 sh1-p27"/>
                <p:cNvPicPr/>
                <p:nvPr/>
              </p:nvPicPr>
              <p:blipFill>
                <a:blip r:embed="rId6"/>
                <a:srcRect l="13915" t="42612" r="57105" b="36211"/>
                <a:stretch/>
              </p:blipFill>
              <p:spPr>
                <a:xfrm>
                  <a:off x="3428640" y="6029640"/>
                  <a:ext cx="1726560" cy="3740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0" name="Picture 6" descr="2014-09-26 A2780 for GFP-PCBP1 and GAPDH_GFP-PCBP1"/>
                <p:cNvPicPr/>
                <p:nvPr/>
              </p:nvPicPr>
              <p:blipFill>
                <a:blip r:embed="rId7"/>
                <a:srcRect l="22873" t="29609" r="49902" b="49322"/>
                <a:stretch/>
              </p:blipFill>
              <p:spPr>
                <a:xfrm>
                  <a:off x="3428640" y="5652720"/>
                  <a:ext cx="1726560" cy="3412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1" name="Text Box 7"/>
                <p:cNvSpPr/>
                <p:nvPr/>
              </p:nvSpPr>
              <p:spPr>
                <a:xfrm rot="18276600">
                  <a:off x="3501360" y="5290200"/>
                  <a:ext cx="565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FP</a:t>
                  </a:r>
                  <a:endParaRPr b="0" lang="en-US" sz="12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2" name="Text Box 8"/>
                <p:cNvSpPr/>
                <p:nvPr/>
              </p:nvSpPr>
              <p:spPr>
                <a:xfrm rot="18276600">
                  <a:off x="3989520" y="5197320"/>
                  <a:ext cx="779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CBP1</a:t>
                  </a:r>
                  <a:endParaRPr b="0" lang="en-US" sz="12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3" name="TextBox 28"/>
                <p:cNvSpPr/>
                <p:nvPr/>
              </p:nvSpPr>
              <p:spPr>
                <a:xfrm>
                  <a:off x="3971880" y="6836400"/>
                  <a:ext cx="676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2780</a:t>
                  </a:r>
                  <a:endParaRPr b="0" lang="en-US" sz="12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4" name="TextBox 29"/>
                <p:cNvSpPr/>
                <p:nvPr/>
              </p:nvSpPr>
              <p:spPr>
                <a:xfrm>
                  <a:off x="2021400" y="6850800"/>
                  <a:ext cx="6451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DLD-1</a:t>
                  </a:r>
                  <a:endParaRPr b="0" lang="en-US" sz="12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pic>
              <p:nvPicPr>
                <p:cNvPr id="75" name="Picture 5" descr="2015-01-21-A2780 and DLD1  p27 KD-GAPDH"/>
                <p:cNvPicPr/>
                <p:nvPr/>
              </p:nvPicPr>
              <p:blipFill>
                <a:blip r:embed="rId8"/>
                <a:srcRect l="42048" t="79532" r="24118" b="16606"/>
                <a:stretch/>
              </p:blipFill>
              <p:spPr>
                <a:xfrm>
                  <a:off x="1196280" y="6445440"/>
                  <a:ext cx="2196000" cy="4201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6" name="Text Box 6"/>
                <p:cNvSpPr/>
                <p:nvPr/>
              </p:nvSpPr>
              <p:spPr>
                <a:xfrm>
                  <a:off x="5114880" y="6515280"/>
                  <a:ext cx="7398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APDH</a:t>
                  </a:r>
                  <a:endParaRPr b="0" lang="en-US" sz="12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7" name="Text Box 8"/>
                <p:cNvSpPr/>
                <p:nvPr/>
              </p:nvSpPr>
              <p:spPr>
                <a:xfrm>
                  <a:off x="5086080" y="5667480"/>
                  <a:ext cx="1047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FP-PCBP1</a:t>
                  </a:r>
                  <a:endParaRPr b="0" lang="en-US" sz="12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8" name="Text Box 17"/>
                <p:cNvSpPr/>
                <p:nvPr/>
              </p:nvSpPr>
              <p:spPr>
                <a:xfrm>
                  <a:off x="5135040" y="6066720"/>
                  <a:ext cx="6181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27</a:t>
                  </a:r>
                  <a:endParaRPr b="0" lang="en-US" sz="12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pic>
              <p:nvPicPr>
                <p:cNvPr id="79" name="Picture 25" descr="2015-01-22-A2780 and DLD1 Cell for p27-p27 and PCBP1"/>
                <p:cNvPicPr/>
                <p:nvPr/>
              </p:nvPicPr>
              <p:blipFill>
                <a:blip r:embed="rId9"/>
                <a:srcRect l="41656" t="18808" r="25126" b="74938"/>
                <a:stretch/>
              </p:blipFill>
              <p:spPr>
                <a:xfrm>
                  <a:off x="1196280" y="5651640"/>
                  <a:ext cx="2196000" cy="343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0" name="Picture 26" descr="2015-01-22-A2780 and DLD1 Cell for p27-p27 and PCBP1"/>
                <p:cNvPicPr/>
                <p:nvPr/>
              </p:nvPicPr>
              <p:blipFill>
                <a:blip r:embed="rId10"/>
                <a:srcRect l="27223" t="83186" r="39470" b="9440"/>
                <a:stretch/>
              </p:blipFill>
              <p:spPr>
                <a:xfrm>
                  <a:off x="1196280" y="6029640"/>
                  <a:ext cx="2196360" cy="3668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1" name="Text Box 7"/>
                <p:cNvSpPr/>
                <p:nvPr/>
              </p:nvSpPr>
              <p:spPr>
                <a:xfrm rot="18276600">
                  <a:off x="1310760" y="5272200"/>
                  <a:ext cx="6228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GFP</a:t>
                  </a:r>
                  <a:endParaRPr b="0" lang="en-US" sz="12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2" name="Text Box 8"/>
                <p:cNvSpPr/>
                <p:nvPr/>
              </p:nvSpPr>
              <p:spPr>
                <a:xfrm rot="18276600">
                  <a:off x="1739520" y="5106240"/>
                  <a:ext cx="10267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CBP1</a:t>
                  </a:r>
                  <a:endParaRPr b="0" lang="en-US" sz="12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83" name="TextBox 119"/>
            <p:cNvSpPr/>
            <p:nvPr/>
          </p:nvSpPr>
          <p:spPr>
            <a:xfrm>
              <a:off x="936360" y="5742720"/>
              <a:ext cx="356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65 -­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TextBox 120"/>
            <p:cNvSpPr/>
            <p:nvPr/>
          </p:nvSpPr>
          <p:spPr>
            <a:xfrm>
              <a:off x="936360" y="6134760"/>
              <a:ext cx="356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7 -­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TextBox 121"/>
            <p:cNvSpPr/>
            <p:nvPr/>
          </p:nvSpPr>
          <p:spPr>
            <a:xfrm>
              <a:off x="937080" y="6516720"/>
              <a:ext cx="380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7 - ­ 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TextBox 122"/>
            <p:cNvSpPr/>
            <p:nvPr/>
          </p:nvSpPr>
          <p:spPr>
            <a:xfrm>
              <a:off x="923760" y="5427360"/>
              <a:ext cx="342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7" name="Rectangle 49"/>
          <p:cNvSpPr/>
          <p:nvPr/>
        </p:nvSpPr>
        <p:spPr>
          <a:xfrm>
            <a:off x="106200" y="132480"/>
            <a:ext cx="653256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2. PCBP1 overexpression inhibits cell cycle progression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A). Representative immunofluorescence staining of A2780 and DLD-1 cells with EdU and Hoechst in cells with endogenous PCBP1 knockdown (PCBP1 KD), GFP-PCBP1 overexpression (PCBP1) and the additional p27KD in PCBP1-overexpressing cells (PCBP1-p27KD)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B). Statistical analyses of EdU positive cells in A. The EdU positive cells were counted randomly in 3 views and analyzed. (mean</a:t>
            </a:r>
            <a:r>
              <a:rPr b="0" lang="en-US" sz="1200" spc="-1" strike="noStrike">
                <a:solidFill>
                  <a:srgbClr val="000000"/>
                </a:solidFill>
                <a:latin typeface="宋体"/>
              </a:rPr>
              <a:t>±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EM, n=3 per group)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C). Representative flow cytometry analysis of A2780 and DLD-1 cells with PCBP1 overexpression after EDU staining. Ratios of EdU+GFP-positive cells to GFP positive cells or GFP-PCBP1-positive cells are shown in the right-upper quadrant of each diagram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Rectangle 50"/>
          <p:cNvSpPr/>
          <p:nvPr/>
        </p:nvSpPr>
        <p:spPr>
          <a:xfrm>
            <a:off x="374760" y="7211160"/>
            <a:ext cx="62816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3. Knockdown efficiency of p27 in A2780 and DLD-1 cell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A). Immunoblots of p27 in DLD-1 and A2780 cells upon its two specific shRNAs transfection after 46 hour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B) Immunoblots of p27 in the stably PCBP1-overexpressing DLD-1 and A2780 cells with supplemental p27 KD with two specific shRNAs. 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dc:description/>
  <dc:language>en-US</dc:language>
  <cp:lastModifiedBy>Hongshun</cp:lastModifiedBy>
  <dcterms:modified xsi:type="dcterms:W3CDTF">2018-06-25T03:13:03Z</dcterms:modified>
  <cp:revision>185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